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F4E79"/>
    <a:srgbClr val="FFA4A4"/>
    <a:srgbClr val="99CCCC"/>
    <a:srgbClr val="2424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F2DE63D5-997A-4646-A377-4702673A728D}" styleName="淡色スタイル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>
      <p:cViewPr varScale="1">
        <p:scale>
          <a:sx n="67" d="100"/>
          <a:sy n="67" d="100"/>
        </p:scale>
        <p:origin x="110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CD750-1095-4E31-B707-7FF36EFD212F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873DA-2CC2-4F19-82B4-E9C42844E5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8953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CD750-1095-4E31-B707-7FF36EFD212F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873DA-2CC2-4F19-82B4-E9C42844E5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5377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CD750-1095-4E31-B707-7FF36EFD212F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873DA-2CC2-4F19-82B4-E9C42844E5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6228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CD750-1095-4E31-B707-7FF36EFD212F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873DA-2CC2-4F19-82B4-E9C42844E5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8668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CD750-1095-4E31-B707-7FF36EFD212F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873DA-2CC2-4F19-82B4-E9C42844E5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7065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CD750-1095-4E31-B707-7FF36EFD212F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873DA-2CC2-4F19-82B4-E9C42844E5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05530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CD750-1095-4E31-B707-7FF36EFD212F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873DA-2CC2-4F19-82B4-E9C42844E5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2705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CD750-1095-4E31-B707-7FF36EFD212F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873DA-2CC2-4F19-82B4-E9C42844E5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0535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CD750-1095-4E31-B707-7FF36EFD212F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873DA-2CC2-4F19-82B4-E9C42844E5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81670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CD750-1095-4E31-B707-7FF36EFD212F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873DA-2CC2-4F19-82B4-E9C42844E5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1124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CD750-1095-4E31-B707-7FF36EFD212F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873DA-2CC2-4F19-82B4-E9C42844E5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5260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2CD750-1095-4E31-B707-7FF36EFD212F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F873DA-2CC2-4F19-82B4-E9C42844E5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4276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53EE40A-A3B0-4B51-B874-D59EEA9D8C64}"/>
              </a:ext>
            </a:extLst>
          </p:cNvPr>
          <p:cNvSpPr txBox="1"/>
          <p:nvPr/>
        </p:nvSpPr>
        <p:spPr>
          <a:xfrm>
            <a:off x="2586037" y="914355"/>
            <a:ext cx="4733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lang="en-US" altLang="ja-JP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1 </a:t>
            </a:r>
            <a:r>
              <a:rPr lang="en-US" altLang="ja-JP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ditions for fine particle bombarding</a:t>
            </a:r>
            <a:endParaRPr lang="ja-JP" altLang="ja-JP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E413EE7D-19CB-4F7F-ABD9-D64266F036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4241428"/>
              </p:ext>
            </p:extLst>
          </p:nvPr>
        </p:nvGraphicFramePr>
        <p:xfrm>
          <a:off x="813000" y="1456685"/>
          <a:ext cx="8280000" cy="2191391"/>
        </p:xfrm>
        <a:graphic>
          <a:graphicData uri="http://schemas.openxmlformats.org/drawingml/2006/table">
            <a:tbl>
              <a:tblPr/>
              <a:tblGrid>
                <a:gridCol w="1080000">
                  <a:extLst>
                    <a:ext uri="{9D8B030D-6E8A-4147-A177-3AD203B41FA5}">
                      <a16:colId xmlns:a16="http://schemas.microsoft.com/office/drawing/2014/main" val="1729661373"/>
                    </a:ext>
                  </a:extLst>
                </a:gridCol>
                <a:gridCol w="1440000">
                  <a:extLst>
                    <a:ext uri="{9D8B030D-6E8A-4147-A177-3AD203B41FA5}">
                      <a16:colId xmlns:a16="http://schemas.microsoft.com/office/drawing/2014/main" val="2185269979"/>
                    </a:ext>
                  </a:extLst>
                </a:gridCol>
                <a:gridCol w="1440000">
                  <a:extLst>
                    <a:ext uri="{9D8B030D-6E8A-4147-A177-3AD203B41FA5}">
                      <a16:colId xmlns:a16="http://schemas.microsoft.com/office/drawing/2014/main" val="2432415974"/>
                    </a:ext>
                  </a:extLst>
                </a:gridCol>
                <a:gridCol w="1440000">
                  <a:extLst>
                    <a:ext uri="{9D8B030D-6E8A-4147-A177-3AD203B41FA5}">
                      <a16:colId xmlns:a16="http://schemas.microsoft.com/office/drawing/2014/main" val="3488890129"/>
                    </a:ext>
                  </a:extLst>
                </a:gridCol>
                <a:gridCol w="1440000">
                  <a:extLst>
                    <a:ext uri="{9D8B030D-6E8A-4147-A177-3AD203B41FA5}">
                      <a16:colId xmlns:a16="http://schemas.microsoft.com/office/drawing/2014/main" val="3487131639"/>
                    </a:ext>
                  </a:extLst>
                </a:gridCol>
                <a:gridCol w="1440000">
                  <a:extLst>
                    <a:ext uri="{9D8B030D-6E8A-4147-A177-3AD203B41FA5}">
                      <a16:colId xmlns:a16="http://schemas.microsoft.com/office/drawing/2014/main" val="3147168786"/>
                    </a:ext>
                  </a:extLst>
                </a:gridCol>
              </a:tblGrid>
              <a:tr h="626831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ja-JP" sz="16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est piece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ja-JP" sz="16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edia</a:t>
                      </a: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ja-JP" sz="16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omponent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ja-JP" sz="16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edian size</a:t>
                      </a: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ja-JP" sz="16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(μm)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ja-JP" sz="16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ir pressure</a:t>
                      </a: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ja-JP" sz="16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(MPa)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istance 　   (mm)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ja-JP" sz="16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rocessing time</a:t>
                      </a: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ja-JP" sz="16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(s)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4947775"/>
                  </a:ext>
                </a:extLst>
              </a:tr>
              <a:tr h="3911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PB-1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C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–1.2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ja-JP" sz="16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5791012"/>
                  </a:ext>
                </a:extLst>
              </a:tr>
              <a:tr h="3911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PB-2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iC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5-4.5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9674966"/>
                  </a:ext>
                </a:extLst>
              </a:tr>
              <a:tr h="3911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PB-3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HB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8–53</a:t>
                      </a:r>
                      <a:endParaRPr lang="ja-JP" sz="16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0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8760826"/>
                  </a:ext>
                </a:extLst>
              </a:tr>
              <a:tr h="39114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PB-4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eel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25–710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5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6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100137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401159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kumimoji="1" sz="1400" dirty="0" smtClean="0"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44</TotalTime>
  <Words>54</Words>
  <Application>Microsoft Office PowerPoint</Application>
  <PresentationFormat>A4 210 x 297 mm</PresentationFormat>
  <Paragraphs>3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.nishitani</dc:creator>
  <cp:lastModifiedBy>kodama nishitani tomoko</cp:lastModifiedBy>
  <cp:revision>187</cp:revision>
  <cp:lastPrinted>2021-02-23T00:58:49Z</cp:lastPrinted>
  <dcterms:created xsi:type="dcterms:W3CDTF">2020-07-06T07:07:03Z</dcterms:created>
  <dcterms:modified xsi:type="dcterms:W3CDTF">2022-01-07T00:30:56Z</dcterms:modified>
</cp:coreProperties>
</file>